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8" r:id="rId2"/>
    <p:sldId id="270" r:id="rId3"/>
    <p:sldId id="269" r:id="rId4"/>
    <p:sldId id="271" r:id="rId5"/>
    <p:sldId id="272" r:id="rId6"/>
    <p:sldId id="27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20" autoAdjust="0"/>
    <p:restoredTop sz="94660"/>
  </p:normalViewPr>
  <p:slideViewPr>
    <p:cSldViewPr snapToGrid="0">
      <p:cViewPr varScale="1">
        <p:scale>
          <a:sx n="92" d="100"/>
          <a:sy n="92" d="100"/>
        </p:scale>
        <p:origin x="9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D3F7CF-E995-45C4-8551-62F08E47B0CB}" type="datetimeFigureOut">
              <a:rPr lang="en-IN" smtClean="0"/>
              <a:t>09/05/22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D41773-2455-4285-AEE9-50CB072552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7438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152059-2482-46A2-9FC8-3BA142C464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668810-AA37-4235-A3F4-98D1AE7B97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43D5FC-D5D5-4357-968E-F90B6402A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32D918-C44D-4119-9725-BF3A05C37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CE412B-7C34-405E-A8BD-9545F7594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869178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DC3C5-6073-43F6-B5F4-5E0A4EF2B8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F97578-0ED5-479E-88F5-C6EF8CBF75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E062A8-E2B2-4874-BA6B-34EC5BCC2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A81C7F-AC30-46BB-A1DB-E25FB62E6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39CA1A-9854-44ED-AF0F-A7BF8294E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243768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C65725-5A73-47F9-A15C-EA5E877657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7D4F81-0C74-4BA0-AB72-B4B0CB74C9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6F6D46-E693-40ED-BD07-0613AEE0F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4232D5-C256-4B8F-803F-D6EADBA89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747D8-4B00-4956-B21A-AEE9D9017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516688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59A533-BF91-411E-88CF-FD298798BD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1F0B29-45C5-4BED-8F28-89DC54DBE0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90E209-8240-4519-B970-50D862D12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393FB6-2B14-47C8-ADBB-633B5BC5A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E7D405-CF72-472E-ABB1-B596D5317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856528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0EB24-FBF0-459B-8F58-8B69E13CF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45D03F-2B63-419E-8A02-84D787363F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86479B-0C1A-4099-B081-1496850DC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5212FA-976A-4500-8E32-DE5936AB6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E4C866-A618-444F-8973-FE1B94365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78467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25EFC3-99CF-49F0-957D-33A8D413C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F12FC5-E9EE-4D0A-AA04-3CD4A3EB85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0A9345-B6C4-4092-800E-04E163D933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72FBC5-4E49-4E80-87EE-0860BBCC0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318892-1DC2-45F0-A134-C949A36D0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8DA383-84AB-477F-BA7E-2A986B6D4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824227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739E35-F07A-4878-A489-E49D94FFB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BE1DFF-3115-4285-B502-9DF1549575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87D5E5-D42D-4080-8BA4-31A055705A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912FFF-1816-4DB4-95C4-E39BFEA5D4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C09A11-5EAF-4542-B789-85831B70CE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DAB167-E33A-4ACD-94CB-C3A7068A1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EC03E2-342A-40A6-83BB-590CF901D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CC5650-D6A7-4B44-A17B-42C4812C5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62729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EDEAA-D350-47C1-B085-085CF7538E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EA9192-E5FC-4675-96E7-8147C02E8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68C89B-35CD-45B8-9D8A-1B678AB0C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5C409A-4686-4F44-B853-02F850C404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662786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EF607B-7DE2-4E6D-88F0-C3DC1F7CF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E97618-BA06-452C-B36E-6987695C3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06EF0C-EF29-4606-B8A6-B006134C0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510712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EF532-5C5C-4E96-B0F9-065689651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DB69D9-3D50-4A42-9B1A-5FDC2B3B16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3059DB-B948-4514-960C-A4C6903836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DF1416-9090-4410-9FBB-9E280B01C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E6C005-292A-40A3-81C0-EEE5CEE749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6880B5-F7E9-4DB6-98FB-1E7647970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356690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0397E5-E45B-4342-90CB-9AD4EBE15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F223202-EBAD-4157-9C86-9D89FCB176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3F5E02-6670-4071-9C12-3A61C7825C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29B87D-EC95-4891-93E7-4979C2F6F0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801097-EA56-4602-B3CB-6C84BB4AE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74A21D-D956-4BD8-84F7-BB9074A1C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063538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E6478E-72E7-4714-A020-13D36E0738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BA38B7-852F-49BE-ACB3-233E7F3128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54D6CA-E388-40F4-BDF1-A82F5D8E68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F81A1-25A6-418E-B30B-0979715F37AC}" type="datetimeFigureOut">
              <a:rPr lang="en-IN" smtClean="0"/>
              <a:t>09/05/22</a:t>
            </a:fld>
            <a:endParaRPr lang="en-IN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3FEFFB-2926-42BA-9B1C-64B77FBAA5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ED381-EC90-47F1-885A-D245220F97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D59FF-42D8-4545-85B7-8907BD2A23ED}" type="slidenum">
              <a:rPr lang="en-IN" smtClean="0"/>
              <a:t>‹#›</a:t>
            </a:fld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496771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93B819E-DFB0-4F34-A91E-351170A99DAE}"/>
              </a:ext>
            </a:extLst>
          </p:cNvPr>
          <p:cNvSpPr txBox="1"/>
          <p:nvPr/>
        </p:nvSpPr>
        <p:spPr>
          <a:xfrm>
            <a:off x="106039" y="66674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9B92D2-E231-8B4D-95D2-D4B00715EEE0}"/>
              </a:ext>
            </a:extLst>
          </p:cNvPr>
          <p:cNvSpPr txBox="1"/>
          <p:nvPr/>
        </p:nvSpPr>
        <p:spPr>
          <a:xfrm>
            <a:off x="257909" y="5740880"/>
            <a:ext cx="1167618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D-L1 immunohistochemistry in relation to the genomic level</a:t>
            </a:r>
          </a:p>
          <a:p>
            <a:pPr defTabSz="457200"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munohistochemistry of PD-L1 in relation to frequency of PDL1/2 gains plus amplifications detected by FISH, divided into PD-L1 negative cases and into PDL-1 expression depending on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HScor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E20EDEF-0CC6-9742-96F2-36F55496FF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073" y="533751"/>
            <a:ext cx="7710736" cy="5109383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8DA35376-C1B9-6548-B0F6-EBE06FC2A53C}"/>
              </a:ext>
            </a:extLst>
          </p:cNvPr>
          <p:cNvCxnSpPr/>
          <p:nvPr/>
        </p:nvCxnSpPr>
        <p:spPr>
          <a:xfrm flipV="1">
            <a:off x="1045029" y="723481"/>
            <a:ext cx="6782637" cy="4059534"/>
          </a:xfrm>
          <a:prstGeom prst="line">
            <a:avLst/>
          </a:prstGeom>
          <a:ln w="15875" cmpd="sng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62450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93B819E-DFB0-4F34-A91E-351170A99DAE}"/>
              </a:ext>
            </a:extLst>
          </p:cNvPr>
          <p:cNvSpPr txBox="1"/>
          <p:nvPr/>
        </p:nvSpPr>
        <p:spPr>
          <a:xfrm>
            <a:off x="106039" y="66674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76993B8-EDE8-3D46-B0E0-4B5904C5FE1E}"/>
              </a:ext>
            </a:extLst>
          </p:cNvPr>
          <p:cNvSpPr txBox="1"/>
          <p:nvPr/>
        </p:nvSpPr>
        <p:spPr>
          <a:xfrm>
            <a:off x="257909" y="4457689"/>
            <a:ext cx="116761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rvival analysis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Kaplan-Meier plot indicating differences in OS based on the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MYD88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 and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CD79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B) mutational status without CNS-DLBCL.</a:t>
            </a:r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CF9572C-E798-3D4A-BA99-F74FE0296210}"/>
              </a:ext>
            </a:extLst>
          </p:cNvPr>
          <p:cNvSpPr txBox="1"/>
          <p:nvPr/>
        </p:nvSpPr>
        <p:spPr>
          <a:xfrm>
            <a:off x="106039" y="605828"/>
            <a:ext cx="672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dirty="0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7E7A784-A449-A947-8A9E-6D886897F5BB}"/>
              </a:ext>
            </a:extLst>
          </p:cNvPr>
          <p:cNvSpPr txBox="1"/>
          <p:nvPr/>
        </p:nvSpPr>
        <p:spPr>
          <a:xfrm>
            <a:off x="6312508" y="605828"/>
            <a:ext cx="672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dirty="0"/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45D0187A-4429-496C-831E-1B7574B694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351" y="1162512"/>
            <a:ext cx="4977111" cy="310782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05BFC29-FAE4-4E5C-A62B-245D1678A4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7501" y="975160"/>
            <a:ext cx="5577187" cy="348252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2D7D68C-67CD-49DE-80E6-BA4631DC05D7}"/>
              </a:ext>
            </a:extLst>
          </p:cNvPr>
          <p:cNvSpPr txBox="1"/>
          <p:nvPr/>
        </p:nvSpPr>
        <p:spPr>
          <a:xfrm>
            <a:off x="826608" y="3054796"/>
            <a:ext cx="263565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1200" dirty="0"/>
              <a:t>N=19 (MYD88 mut), N=33 (MYD88 WT)</a:t>
            </a:r>
          </a:p>
          <a:p>
            <a:r>
              <a:rPr lang="en-IN" sz="1200" dirty="0"/>
              <a:t>p=0.0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C8D933F-D6DB-47EF-BB4F-14EA7FD0EA69}"/>
              </a:ext>
            </a:extLst>
          </p:cNvPr>
          <p:cNvSpPr txBox="1"/>
          <p:nvPr/>
        </p:nvSpPr>
        <p:spPr>
          <a:xfrm>
            <a:off x="6661994" y="3182834"/>
            <a:ext cx="2552302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1200" dirty="0"/>
              <a:t>N=18 (CD79B mut), N=34 (CD79B WT)</a:t>
            </a:r>
          </a:p>
          <a:p>
            <a:r>
              <a:rPr lang="en-IN" sz="1200" dirty="0"/>
              <a:t>p=0.6</a:t>
            </a:r>
          </a:p>
        </p:txBody>
      </p:sp>
    </p:spTree>
    <p:extLst>
      <p:ext uri="{BB962C8B-B14F-4D97-AF65-F5344CB8AC3E}">
        <p14:creationId xmlns:p14="http://schemas.microsoft.com/office/powerpoint/2010/main" val="12463145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93B819E-DFB0-4F34-A91E-351170A99DAE}"/>
              </a:ext>
            </a:extLst>
          </p:cNvPr>
          <p:cNvSpPr txBox="1"/>
          <p:nvPr/>
        </p:nvSpPr>
        <p:spPr>
          <a:xfrm>
            <a:off x="106039" y="66674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27AF09-76C1-7640-9D54-5D59CD5A984B}"/>
              </a:ext>
            </a:extLst>
          </p:cNvPr>
          <p:cNvSpPr txBox="1"/>
          <p:nvPr/>
        </p:nvSpPr>
        <p:spPr>
          <a:xfrm>
            <a:off x="257909" y="5011124"/>
            <a:ext cx="116761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rvival analysis</a:t>
            </a:r>
          </a:p>
          <a:p>
            <a:pPr defTabSz="457200"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Kaplan-Meier plot indicating differences in OS based on the immunohistochemistry of PD-L1 (A) and CD30 (B), without PMBL. </a:t>
            </a:r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EB8A87C-A8E6-E341-BDA4-3558E2708D95}"/>
              </a:ext>
            </a:extLst>
          </p:cNvPr>
          <p:cNvSpPr txBox="1"/>
          <p:nvPr/>
        </p:nvSpPr>
        <p:spPr>
          <a:xfrm>
            <a:off x="106039" y="751547"/>
            <a:ext cx="554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961ABDB-D332-7344-BF9A-4B425765C860}"/>
              </a:ext>
            </a:extLst>
          </p:cNvPr>
          <p:cNvSpPr txBox="1"/>
          <p:nvPr/>
        </p:nvSpPr>
        <p:spPr>
          <a:xfrm>
            <a:off x="6238103" y="796427"/>
            <a:ext cx="672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dirty="0"/>
              <a:t>B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43598A65-7000-4A9D-AF01-67A11DF920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039" y="1120879"/>
            <a:ext cx="5710536" cy="356579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FD1173B-CB14-48E2-9A42-C4FE7B6EAC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16575" y="1120878"/>
            <a:ext cx="5710535" cy="356579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E3A0E59-CE1D-485B-ABCF-37436EE7DB3C}"/>
              </a:ext>
            </a:extLst>
          </p:cNvPr>
          <p:cNvSpPr txBox="1"/>
          <p:nvPr/>
        </p:nvSpPr>
        <p:spPr>
          <a:xfrm>
            <a:off x="660837" y="3400125"/>
            <a:ext cx="2353529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1200" dirty="0"/>
              <a:t>N=5 (PD-L1 </a:t>
            </a:r>
            <a:r>
              <a:rPr lang="en-IN" sz="1200" dirty="0" err="1"/>
              <a:t>pos</a:t>
            </a:r>
            <a:r>
              <a:rPr lang="en-IN" sz="1200" dirty="0"/>
              <a:t>), N=52 (PD-L1 neg)</a:t>
            </a:r>
          </a:p>
          <a:p>
            <a:r>
              <a:rPr lang="en-IN" sz="1200" dirty="0"/>
              <a:t>p=0.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B854F5-9E2C-41E7-9B6C-99B0C0B06118}"/>
              </a:ext>
            </a:extLst>
          </p:cNvPr>
          <p:cNvSpPr txBox="1"/>
          <p:nvPr/>
        </p:nvSpPr>
        <p:spPr>
          <a:xfrm>
            <a:off x="6347328" y="3400125"/>
            <a:ext cx="2371162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1200" dirty="0"/>
              <a:t>N=13 (CD30 </a:t>
            </a:r>
            <a:r>
              <a:rPr lang="en-IN" sz="1200" dirty="0" err="1"/>
              <a:t>pos</a:t>
            </a:r>
            <a:r>
              <a:rPr lang="en-IN" sz="1200" dirty="0"/>
              <a:t>), N=49 (CD30 neg)</a:t>
            </a:r>
          </a:p>
          <a:p>
            <a:r>
              <a:rPr lang="en-IN" sz="1200" dirty="0"/>
              <a:t>p=0.6</a:t>
            </a:r>
          </a:p>
        </p:txBody>
      </p:sp>
    </p:spTree>
    <p:extLst>
      <p:ext uri="{BB962C8B-B14F-4D97-AF65-F5344CB8AC3E}">
        <p14:creationId xmlns:p14="http://schemas.microsoft.com/office/powerpoint/2010/main" val="13327714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93B819E-DFB0-4F34-A91E-351170A99DAE}"/>
              </a:ext>
            </a:extLst>
          </p:cNvPr>
          <p:cNvSpPr txBox="1"/>
          <p:nvPr/>
        </p:nvSpPr>
        <p:spPr>
          <a:xfrm>
            <a:off x="106039" y="66674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27AF09-76C1-7640-9D54-5D59CD5A984B}"/>
              </a:ext>
            </a:extLst>
          </p:cNvPr>
          <p:cNvSpPr txBox="1"/>
          <p:nvPr/>
        </p:nvSpPr>
        <p:spPr>
          <a:xfrm>
            <a:off x="257909" y="5880337"/>
            <a:ext cx="116761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Correlation between PD-L1 IHC and relative copy gain or amplification detected by FISH in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MYD88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CD79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mutated cases. Abbr. TPS, Tumor Proportion Score</a:t>
            </a:r>
          </a:p>
          <a:p>
            <a:pPr defTabSz="457200">
              <a:defRPr/>
            </a:pPr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A5441D7-550C-8048-9FD7-513694F7E1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909" y="583795"/>
            <a:ext cx="8559800" cy="5148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94778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93B819E-DFB0-4F34-A91E-351170A99DAE}"/>
              </a:ext>
            </a:extLst>
          </p:cNvPr>
          <p:cNvSpPr txBox="1"/>
          <p:nvPr/>
        </p:nvSpPr>
        <p:spPr>
          <a:xfrm>
            <a:off x="106039" y="66674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27AF09-76C1-7640-9D54-5D59CD5A984B}"/>
              </a:ext>
            </a:extLst>
          </p:cNvPr>
          <p:cNvSpPr txBox="1"/>
          <p:nvPr/>
        </p:nvSpPr>
        <p:spPr>
          <a:xfrm>
            <a:off x="257909" y="5880337"/>
            <a:ext cx="116761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Correlation between PD-L1 IHC and relative copy gain or amplification detected by FISH in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MYD88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mutated cases. Abbr. TPS, Tumor Proportion Score</a:t>
            </a:r>
          </a:p>
          <a:p>
            <a:pPr defTabSz="457200">
              <a:defRPr/>
            </a:pPr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D981E7B-287E-6D4E-86D6-5ED9E12675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909" y="565036"/>
            <a:ext cx="8644931" cy="53153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06437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93B819E-DFB0-4F34-A91E-351170A99DAE}"/>
              </a:ext>
            </a:extLst>
          </p:cNvPr>
          <p:cNvSpPr txBox="1"/>
          <p:nvPr/>
        </p:nvSpPr>
        <p:spPr>
          <a:xfrm>
            <a:off x="106039" y="66674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27AF09-76C1-7640-9D54-5D59CD5A984B}"/>
              </a:ext>
            </a:extLst>
          </p:cNvPr>
          <p:cNvSpPr txBox="1"/>
          <p:nvPr/>
        </p:nvSpPr>
        <p:spPr>
          <a:xfrm>
            <a:off x="257909" y="5880337"/>
            <a:ext cx="116761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Correlation between PD-L1 IHC and relative copy gain or amplification detected by FISH in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CD79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mutated cases. Abbr. TPS, Tumor Proportion Score</a:t>
            </a:r>
          </a:p>
          <a:p>
            <a:pPr defTabSz="457200">
              <a:defRPr/>
            </a:pPr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276E317-2AB3-2845-850D-F7FD737393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908" y="573384"/>
            <a:ext cx="7911401" cy="5288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033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7</TotalTime>
  <Words>284</Words>
  <Application>Microsoft Macintosh PowerPoint</Application>
  <PresentationFormat>Widescreen</PresentationFormat>
  <Paragraphs>2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cha Dugge</dc:creator>
  <cp:lastModifiedBy>Stephanie Weißinger</cp:lastModifiedBy>
  <cp:revision>48</cp:revision>
  <dcterms:created xsi:type="dcterms:W3CDTF">2021-11-17T14:41:19Z</dcterms:created>
  <dcterms:modified xsi:type="dcterms:W3CDTF">2022-05-09T14:39:06Z</dcterms:modified>
</cp:coreProperties>
</file>